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8" d="100"/>
          <a:sy n="78" d="100"/>
        </p:scale>
        <p:origin x="21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09FB30-FA32-4615-93F4-26F2E5E6C7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3FFAF80-E5E9-4149-8C15-1E9F08CFEC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3C0CCF-0270-479B-A2E3-689FAE1411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5FAA5-0804-4713-9EBD-7F4E72925402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5BBC5B-1D4B-4AFA-A04E-FA81111AA4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BB4549-237D-44DF-A3F3-7A777C27CE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6A2AB-5558-4EED-B3E5-3D0F001FC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8984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7F34E6-71EE-44F4-B695-95B3B522C0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F7C433D-1819-412D-952E-625CE08F15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1472B2-FEBD-4FBE-8361-E92E9FE026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5FAA5-0804-4713-9EBD-7F4E72925402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7C4033-4EC6-4F2F-BEFA-7637312CB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E36F47-690C-4C50-A6F1-8156EFFD02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6A2AB-5558-4EED-B3E5-3D0F001FC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9923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9C31D38-9DD8-4A45-A036-59963A758E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285249-666A-4B84-8ED7-2E243DB569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CC1743-C4C7-49B7-8CF2-AFF35383B7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5FAA5-0804-4713-9EBD-7F4E72925402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C2A6C0-3C63-4045-880D-A0FC68C23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8543E7-1FD8-4784-834E-77AF0403AE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6A2AB-5558-4EED-B3E5-3D0F001FC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5811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44F972-CA68-4CC4-BC9E-7BE5E10594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55766E-C49D-4146-8358-DC8C2A7B139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D208C3-B2AD-4F5C-B589-A45F4A3318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5FAA5-0804-4713-9EBD-7F4E72925402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0F6BAE-2099-4576-BECD-0272BD3DF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4EDD03-6A09-4640-8173-EC1DA87EC8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6A2AB-5558-4EED-B3E5-3D0F001FC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6855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4C28EF-4985-42AD-86FC-19E6FC40F9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79D1DA-23AF-4770-A565-4C4361DCA2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AB23A0-40CE-493A-A1B3-CD8D36401D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5FAA5-0804-4713-9EBD-7F4E72925402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983CFC-DDCB-4E4A-BB56-80C80A8DAE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77665B-5900-4207-83EB-CFDCE7207A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6A2AB-5558-4EED-B3E5-3D0F001FC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96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5C95B9-E3E1-4BC4-B2CF-65CA11A8AF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52ACD1-ADD9-45A7-A39F-62F5FDE9B0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2DAE5B-2EA6-4DE5-B5C1-9DADF36D75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A2C13F-B72A-4662-A5F2-672DF26B97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5FAA5-0804-4713-9EBD-7F4E72925402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F7AB2E-284E-41D6-A61B-7367821233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685151-8870-411A-8784-C7048A1F45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6A2AB-5558-4EED-B3E5-3D0F001FC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3459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27AA99-3A41-4483-A817-040904D2A9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EB4661-E4CD-4BBE-B479-5C44EE2058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21C67AA-6E4B-4E94-BCE9-5A75B5DFED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15C0D1D-C2A2-47CC-8BD1-87B8CC0E4DB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460CC90-BD3F-4A64-AF69-4407D8E233C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626C448-68AC-40C0-AF4E-797DE6967B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5FAA5-0804-4713-9EBD-7F4E72925402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0E206DD-EB04-4AD2-813B-3FA043D63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8F1FCA3-3191-440D-BFC2-7F6D5C6795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6A2AB-5558-4EED-B3E5-3D0F001FC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15262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406743-E4E2-4791-AD3B-527AA0331A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1DE3C4B-BCE3-4ED5-8EB6-7EAB6B1BE0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5FAA5-0804-4713-9EBD-7F4E72925402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9CF61FE-B669-4739-A11C-C9D97FF67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7A28A91-FA34-471B-8F57-E60F90A9D0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6A2AB-5558-4EED-B3E5-3D0F001FC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454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5285BCC-EBD4-407F-820A-42D2D37889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5FAA5-0804-4713-9EBD-7F4E72925402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CA1A44D-C4E8-4166-AC9A-7B9242CA4A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0B17C2E-DB18-483E-8D4A-7FB06C05F6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6A2AB-5558-4EED-B3E5-3D0F001FC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7192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84D2F-827E-41BF-B4DF-3196C4B9B7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C1CB65-5E94-47E1-83E4-2750DF973B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6105D5-CC55-4775-851F-7FE8077C7F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4FA4AA-B4F7-4C20-A887-3F79C11290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5FAA5-0804-4713-9EBD-7F4E72925402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2196DD-05AA-403A-8EF9-1AD3926FF7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D4D711-31A4-476C-89CE-75FD9C04D1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6A2AB-5558-4EED-B3E5-3D0F001FC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0269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69DBE7-13AE-4D26-9F1A-2CFF622546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8770E14-45A3-4C3B-85F7-89A2FD5CBE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86D940-A2D4-4874-8CE2-8D558C0511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37D0ABF-7A7D-429B-99E9-C846286733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5FAA5-0804-4713-9EBD-7F4E72925402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87A0E5-19AD-4D58-919F-AFDCC0F4E7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86E92C-7F87-4C73-B937-CD971B6DD1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6A2AB-5558-4EED-B3E5-3D0F001FC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66840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FDC9014-DBB6-4CC3-B161-DCE162E683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2A8974-3DCA-484F-AB4D-B4F253CBD5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C49104-6FB8-40D9-A990-DEA29FB8669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55FAA5-0804-4713-9EBD-7F4E72925402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FE7076-4E4A-42E1-812A-CC899B6D62E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05E974-C3BB-4FE2-8B39-5B634A452F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A6A2AB-5558-4EED-B3E5-3D0F001FC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3951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51F1C4B-E361-4C1C-AAE2-218B41FC43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597" y="873276"/>
            <a:ext cx="7530986" cy="499255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629C17A-17BC-4F2C-953B-539DBC16EE82}"/>
              </a:ext>
            </a:extLst>
          </p:cNvPr>
          <p:cNvSpPr txBox="1"/>
          <p:nvPr/>
        </p:nvSpPr>
        <p:spPr>
          <a:xfrm>
            <a:off x="1654933" y="5865826"/>
            <a:ext cx="95042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PI networks of SKBR3 cell membrane proteins (1127) matched to the hallmarks of cancer</a:t>
            </a:r>
          </a:p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 nodes represent hallmark proteins documented in the literature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098E349-7EAE-4351-8212-D528405EE728}"/>
              </a:ext>
            </a:extLst>
          </p:cNvPr>
          <p:cNvSpPr txBox="1"/>
          <p:nvPr/>
        </p:nvSpPr>
        <p:spPr>
          <a:xfrm>
            <a:off x="1214775" y="477711"/>
            <a:ext cx="10099467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pping the Cell-Membrane Proteome to the Cancer Hallmarks</a:t>
            </a:r>
          </a:p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zar IM,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rcini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,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uei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JRS </a:t>
            </a:r>
          </a:p>
        </p:txBody>
      </p:sp>
    </p:spTree>
    <p:extLst>
      <p:ext uri="{BB962C8B-B14F-4D97-AF65-F5344CB8AC3E}">
        <p14:creationId xmlns:p14="http://schemas.microsoft.com/office/powerpoint/2010/main" val="29451243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41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uliaLazar</dc:creator>
  <cp:lastModifiedBy>Iuliana Lazar</cp:lastModifiedBy>
  <cp:revision>5</cp:revision>
  <dcterms:created xsi:type="dcterms:W3CDTF">2022-01-29T18:40:33Z</dcterms:created>
  <dcterms:modified xsi:type="dcterms:W3CDTF">2022-04-15T17:52:59Z</dcterms:modified>
</cp:coreProperties>
</file>